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830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093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814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888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155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45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238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361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89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292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569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ED818B-CAF2-4C66-9738-6AC001CD72C6}" type="datetimeFigureOut">
              <a:rPr lang="en-US" smtClean="0"/>
              <a:t>10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991CF-6142-4342-9FB6-C0576AFD2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137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jpeg"/><Relationship Id="rId4" Type="http://schemas.openxmlformats.org/officeDocument/2006/relationships/image" Target="../media/image13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jpeg"/><Relationship Id="rId4" Type="http://schemas.openxmlformats.org/officeDocument/2006/relationships/image" Target="../media/image1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8500" y="1290637"/>
            <a:ext cx="5715000" cy="4276725"/>
          </a:xfrm>
          <a:prstGeom prst="rect">
            <a:avLst/>
          </a:prstGeom>
        </p:spPr>
      </p:pic>
      <p:sp>
        <p:nvSpPr>
          <p:cNvPr id="5" name="TextBox 31"/>
          <p:cNvSpPr txBox="1"/>
          <p:nvPr/>
        </p:nvSpPr>
        <p:spPr>
          <a:xfrm rot="16200000">
            <a:off x="4798829" y="1721959"/>
            <a:ext cx="5935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32"/>
          <p:cNvSpPr txBox="1"/>
          <p:nvPr/>
        </p:nvSpPr>
        <p:spPr>
          <a:xfrm rot="16200000">
            <a:off x="4013422" y="1734905"/>
            <a:ext cx="5056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33"/>
          <p:cNvSpPr txBox="1"/>
          <p:nvPr/>
        </p:nvSpPr>
        <p:spPr>
          <a:xfrm rot="16200000">
            <a:off x="5982974" y="1739109"/>
            <a:ext cx="497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34"/>
          <p:cNvSpPr txBox="1"/>
          <p:nvPr/>
        </p:nvSpPr>
        <p:spPr>
          <a:xfrm rot="16200000">
            <a:off x="7031791" y="1734904"/>
            <a:ext cx="5056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35"/>
          <p:cNvSpPr txBox="1"/>
          <p:nvPr/>
        </p:nvSpPr>
        <p:spPr>
          <a:xfrm rot="16200000">
            <a:off x="4283416" y="1734902"/>
            <a:ext cx="5056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1_1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36"/>
          <p:cNvSpPr txBox="1"/>
          <p:nvPr/>
        </p:nvSpPr>
        <p:spPr>
          <a:xfrm rot="16200000">
            <a:off x="6137884" y="1734903"/>
            <a:ext cx="5056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1_1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37"/>
          <p:cNvSpPr txBox="1"/>
          <p:nvPr/>
        </p:nvSpPr>
        <p:spPr>
          <a:xfrm rot="16200000">
            <a:off x="7298348" y="1734902"/>
            <a:ext cx="5056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1_1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38"/>
          <p:cNvSpPr txBox="1"/>
          <p:nvPr/>
        </p:nvSpPr>
        <p:spPr>
          <a:xfrm rot="16200000">
            <a:off x="4519823" y="1734901"/>
            <a:ext cx="5056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1_2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39"/>
          <p:cNvSpPr txBox="1"/>
          <p:nvPr/>
        </p:nvSpPr>
        <p:spPr>
          <a:xfrm rot="16200000">
            <a:off x="6310929" y="1734903"/>
            <a:ext cx="5056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1_2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40"/>
          <p:cNvSpPr txBox="1"/>
          <p:nvPr/>
        </p:nvSpPr>
        <p:spPr>
          <a:xfrm rot="16200000">
            <a:off x="7602210" y="1734901"/>
            <a:ext cx="5056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1_2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41"/>
          <p:cNvSpPr txBox="1"/>
          <p:nvPr/>
        </p:nvSpPr>
        <p:spPr>
          <a:xfrm rot="16200000">
            <a:off x="5653942" y="1734903"/>
            <a:ext cx="5056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42"/>
          <p:cNvSpPr txBox="1"/>
          <p:nvPr/>
        </p:nvSpPr>
        <p:spPr>
          <a:xfrm rot="16200000">
            <a:off x="6466376" y="1734903"/>
            <a:ext cx="5056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43"/>
          <p:cNvSpPr txBox="1"/>
          <p:nvPr/>
        </p:nvSpPr>
        <p:spPr>
          <a:xfrm rot="16200000">
            <a:off x="7775259" y="1743314"/>
            <a:ext cx="5056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584449" y="857772"/>
            <a:ext cx="4162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riginal gel of </a:t>
            </a:r>
            <a:r>
              <a:rPr lang="en-US" i="1" dirty="0" smtClean="0"/>
              <a:t>PeLysM1</a:t>
            </a:r>
            <a:r>
              <a:rPr lang="en-US" dirty="0" smtClean="0"/>
              <a:t> from </a:t>
            </a:r>
            <a:r>
              <a:rPr lang="en-US" dirty="0" smtClean="0"/>
              <a:t>S1b </a:t>
            </a:r>
            <a:r>
              <a:rPr lang="en-US" dirty="0" smtClean="0"/>
              <a:t>Fig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84418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8500" y="1290637"/>
            <a:ext cx="5715000" cy="4276725"/>
          </a:xfrm>
          <a:prstGeom prst="rect">
            <a:avLst/>
          </a:prstGeom>
        </p:spPr>
      </p:pic>
      <p:sp>
        <p:nvSpPr>
          <p:cNvPr id="24" name="TextBox 120"/>
          <p:cNvSpPr txBox="1"/>
          <p:nvPr/>
        </p:nvSpPr>
        <p:spPr>
          <a:xfrm rot="16200000">
            <a:off x="4573495" y="1515687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121"/>
          <p:cNvSpPr txBox="1"/>
          <p:nvPr/>
        </p:nvSpPr>
        <p:spPr>
          <a:xfrm rot="16200000">
            <a:off x="3523947" y="1427911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122"/>
          <p:cNvSpPr txBox="1"/>
          <p:nvPr/>
        </p:nvSpPr>
        <p:spPr>
          <a:xfrm rot="16200000">
            <a:off x="5364720" y="1486040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123"/>
          <p:cNvSpPr txBox="1"/>
          <p:nvPr/>
        </p:nvSpPr>
        <p:spPr>
          <a:xfrm rot="16200000">
            <a:off x="6902190" y="1476026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124"/>
          <p:cNvSpPr txBox="1"/>
          <p:nvPr/>
        </p:nvSpPr>
        <p:spPr>
          <a:xfrm rot="16200000">
            <a:off x="3827118" y="1425261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125"/>
          <p:cNvSpPr txBox="1"/>
          <p:nvPr/>
        </p:nvSpPr>
        <p:spPr>
          <a:xfrm rot="16200000">
            <a:off x="5875205" y="1477459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1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126"/>
          <p:cNvSpPr txBox="1"/>
          <p:nvPr/>
        </p:nvSpPr>
        <p:spPr>
          <a:xfrm rot="16200000">
            <a:off x="7428348" y="1456101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1</a:t>
            </a: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127"/>
          <p:cNvSpPr txBox="1"/>
          <p:nvPr/>
        </p:nvSpPr>
        <p:spPr>
          <a:xfrm rot="16200000">
            <a:off x="4074600" y="1478661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1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128"/>
          <p:cNvSpPr txBox="1"/>
          <p:nvPr/>
        </p:nvSpPr>
        <p:spPr>
          <a:xfrm rot="16200000">
            <a:off x="6122862" y="1454632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2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129"/>
          <p:cNvSpPr txBox="1"/>
          <p:nvPr/>
        </p:nvSpPr>
        <p:spPr>
          <a:xfrm rot="16200000">
            <a:off x="7697665" y="1454632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2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130"/>
          <p:cNvSpPr txBox="1"/>
          <p:nvPr/>
        </p:nvSpPr>
        <p:spPr>
          <a:xfrm rot="16200000">
            <a:off x="4797669" y="1515687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131"/>
          <p:cNvSpPr txBox="1"/>
          <p:nvPr/>
        </p:nvSpPr>
        <p:spPr>
          <a:xfrm rot="16200000">
            <a:off x="6412950" y="1468765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132"/>
          <p:cNvSpPr txBox="1"/>
          <p:nvPr/>
        </p:nvSpPr>
        <p:spPr>
          <a:xfrm rot="16200000">
            <a:off x="7929374" y="1486040"/>
            <a:ext cx="510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4363528" y="1499004"/>
            <a:ext cx="441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2</a:t>
            </a: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5704710" y="1515687"/>
            <a:ext cx="388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7242766" y="1476026"/>
            <a:ext cx="388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121713" y="857772"/>
            <a:ext cx="3785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riginal gel of </a:t>
            </a:r>
            <a:r>
              <a:rPr lang="en-US" i="1" dirty="0" smtClean="0"/>
              <a:t>PeLysM2</a:t>
            </a:r>
            <a:r>
              <a:rPr lang="en-US" dirty="0" smtClean="0"/>
              <a:t> </a:t>
            </a:r>
            <a:r>
              <a:rPr lang="en-US" dirty="0" smtClean="0"/>
              <a:t>from S1b</a:t>
            </a:r>
            <a:r>
              <a:rPr lang="en-US" dirty="0" smtClean="0"/>
              <a:t> </a:t>
            </a:r>
            <a:r>
              <a:rPr lang="en-US" dirty="0" smtClean="0"/>
              <a:t>Fig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26365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121713" y="857772"/>
            <a:ext cx="3785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riginal gel of </a:t>
            </a:r>
            <a:r>
              <a:rPr lang="en-US" i="1" dirty="0" smtClean="0"/>
              <a:t>PeLysM3</a:t>
            </a:r>
            <a:r>
              <a:rPr lang="en-US" dirty="0" smtClean="0"/>
              <a:t> from </a:t>
            </a:r>
            <a:r>
              <a:rPr lang="en-US" dirty="0" smtClean="0"/>
              <a:t>S1b </a:t>
            </a:r>
            <a:r>
              <a:rPr lang="en-US" dirty="0" smtClean="0"/>
              <a:t>Fig.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8460" y="1674685"/>
            <a:ext cx="5715000" cy="4276725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 rot="16200000">
            <a:off x="4342742" y="2091990"/>
            <a:ext cx="512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3227284" y="2091991"/>
            <a:ext cx="512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5110785" y="2091992"/>
            <a:ext cx="512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6655986" y="2091992"/>
            <a:ext cx="512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3590732" y="2153714"/>
            <a:ext cx="388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5606707" y="2089790"/>
            <a:ext cx="5076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3_1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7105919" y="2043802"/>
            <a:ext cx="5996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3_1</a:t>
            </a: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3869566" y="2130823"/>
            <a:ext cx="434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3_1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6200000">
            <a:off x="5919833" y="2128623"/>
            <a:ext cx="4300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3_2</a:t>
            </a: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7453634" y="2089790"/>
            <a:ext cx="5076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3_2</a:t>
            </a: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4598748" y="2091992"/>
            <a:ext cx="512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6143949" y="2091992"/>
            <a:ext cx="512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6200000">
            <a:off x="7753163" y="2128623"/>
            <a:ext cx="5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 rot="16200000">
            <a:off x="4088203" y="2098343"/>
            <a:ext cx="5091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3_2</a:t>
            </a: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5340823" y="2091992"/>
            <a:ext cx="5091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6913456" y="2090529"/>
            <a:ext cx="5091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52072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394553" y="584349"/>
            <a:ext cx="3785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riginal gel of </a:t>
            </a:r>
            <a:r>
              <a:rPr lang="en-US" i="1" dirty="0" smtClean="0"/>
              <a:t>PeLysM4</a:t>
            </a:r>
            <a:r>
              <a:rPr lang="en-US" dirty="0" smtClean="0"/>
              <a:t> from </a:t>
            </a:r>
            <a:r>
              <a:rPr lang="en-US" dirty="0" smtClean="0"/>
              <a:t>S1b </a:t>
            </a:r>
            <a:r>
              <a:rPr lang="en-US" dirty="0" smtClean="0"/>
              <a:t>Fig.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17590" r="16867"/>
          <a:stretch/>
        </p:blipFill>
        <p:spPr>
          <a:xfrm>
            <a:off x="1893601" y="1786986"/>
            <a:ext cx="2996589" cy="342138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21014" r="16818"/>
          <a:stretch/>
        </p:blipFill>
        <p:spPr>
          <a:xfrm>
            <a:off x="5141363" y="1786986"/>
            <a:ext cx="2842352" cy="342138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/>
          <a:srcRect l="20081" r="13896"/>
          <a:stretch/>
        </p:blipFill>
        <p:spPr>
          <a:xfrm>
            <a:off x="8538072" y="1786986"/>
            <a:ext cx="3018622" cy="3421380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 rot="16200000">
            <a:off x="3533538" y="2034759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2250905" y="2034760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8979995" y="2023743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2570102" y="2034758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9606875" y="2023743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1</a:t>
            </a: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2831628" y="2034759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1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9920315" y="2023743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2</a:t>
            </a: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3884493" y="2096924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10233755" y="2023743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6200000">
            <a:off x="3247419" y="2096924"/>
            <a:ext cx="457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2</a:t>
            </a: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9392526" y="1924652"/>
            <a:ext cx="388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5474791" y="2099024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100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6101671" y="2099024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1</a:t>
            </a: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6415111" y="2099024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2</a:t>
            </a: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6200000">
            <a:off x="6728551" y="2099024"/>
            <a:ext cx="58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5887322" y="1999933"/>
            <a:ext cx="388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98508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879" y="2249103"/>
            <a:ext cx="5715000" cy="427672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35937" y="2249103"/>
            <a:ext cx="5715000" cy="42767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121713" y="857772"/>
            <a:ext cx="3785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riginal gel of </a:t>
            </a:r>
            <a:r>
              <a:rPr lang="en-US" i="1" dirty="0" smtClean="0"/>
              <a:t>PeLysM1</a:t>
            </a:r>
            <a:r>
              <a:rPr lang="en-US" dirty="0" smtClean="0"/>
              <a:t> from </a:t>
            </a:r>
            <a:r>
              <a:rPr lang="en-US" dirty="0" smtClean="0"/>
              <a:t>S1C </a:t>
            </a:r>
            <a:r>
              <a:rPr lang="en-US" dirty="0" smtClean="0"/>
              <a:t>Fig.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960572" y="1553437"/>
            <a:ext cx="1080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PeLysM1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8453395" y="1553437"/>
            <a:ext cx="1080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37S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1755061" y="2621932"/>
            <a:ext cx="6464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3184269" y="2621931"/>
            <a:ext cx="565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1_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3569427" y="2621932"/>
            <a:ext cx="565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1_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7834548" y="2774332"/>
            <a:ext cx="6464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9263756" y="2774331"/>
            <a:ext cx="565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1_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9773615" y="2774330"/>
            <a:ext cx="565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1_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7" name="Group 339"/>
          <p:cNvGrpSpPr>
            <a:grpSpLocks noChangeAspect="1"/>
          </p:cNvGrpSpPr>
          <p:nvPr/>
        </p:nvGrpSpPr>
        <p:grpSpPr>
          <a:xfrm>
            <a:off x="9546649" y="312741"/>
            <a:ext cx="1826699" cy="1057974"/>
            <a:chOff x="5236467" y="2920174"/>
            <a:chExt cx="2706222" cy="1567370"/>
          </a:xfrm>
        </p:grpSpPr>
        <p:grpSp>
          <p:nvGrpSpPr>
            <p:cNvPr id="28" name="Group 19"/>
            <p:cNvGrpSpPr/>
            <p:nvPr/>
          </p:nvGrpSpPr>
          <p:grpSpPr>
            <a:xfrm>
              <a:off x="6248400" y="4114800"/>
              <a:ext cx="1522866" cy="304800"/>
              <a:chOff x="5029200" y="4038600"/>
              <a:chExt cx="1522866" cy="304800"/>
            </a:xfrm>
          </p:grpSpPr>
          <p:pic>
            <p:nvPicPr>
              <p:cNvPr id="39" name="Picture 2" descr="ftp://ftp.agri.gov.il/Technology/Postharvest/Elena/2014/PCR_37S_26_1_14/PCR_37S1%20neg2014-01-26%2010hr%2030min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56338" t="30810" r="27778" b="62652"/>
              <a:stretch>
                <a:fillRect/>
              </a:stretch>
            </p:blipFill>
            <p:spPr bwMode="auto">
              <a:xfrm>
                <a:off x="5562600" y="4038600"/>
                <a:ext cx="989466" cy="304800"/>
              </a:xfrm>
              <a:prstGeom prst="rect">
                <a:avLst/>
              </a:prstGeom>
              <a:noFill/>
              <a:ln w="19050">
                <a:noFill/>
              </a:ln>
            </p:spPr>
          </p:pic>
          <p:pic>
            <p:nvPicPr>
              <p:cNvPr id="40" name="Picture 2" descr="ftp://ftp.agri.gov.il/Technology/Postharvest/Elena/2014/PCR_37S_26_1_14/PCR_37S1%20neg2014-01-26%2010hr%2030min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30650" t="32445" r="60787" b="61026"/>
              <a:stretch>
                <a:fillRect/>
              </a:stretch>
            </p:blipFill>
            <p:spPr bwMode="auto">
              <a:xfrm>
                <a:off x="5029200" y="4039007"/>
                <a:ext cx="533400" cy="304393"/>
              </a:xfrm>
              <a:prstGeom prst="rect">
                <a:avLst/>
              </a:prstGeom>
              <a:noFill/>
              <a:ln w="19050">
                <a:noFill/>
              </a:ln>
            </p:spPr>
          </p:pic>
        </p:grpSp>
        <p:grpSp>
          <p:nvGrpSpPr>
            <p:cNvPr id="29" name="Group 18"/>
            <p:cNvGrpSpPr/>
            <p:nvPr/>
          </p:nvGrpSpPr>
          <p:grpSpPr>
            <a:xfrm>
              <a:off x="6248400" y="3733800"/>
              <a:ext cx="1520208" cy="291067"/>
              <a:chOff x="5029200" y="3733800"/>
              <a:chExt cx="1520208" cy="291067"/>
            </a:xfrm>
          </p:grpSpPr>
          <p:pic>
            <p:nvPicPr>
              <p:cNvPr id="37" name="Picture 4" descr="ftp://ftp.agri.gov.il/Technology/Postharvest/Elena/2014/PCR_34030_26_1_14/PCR%2034030%20neg2014-01-26%2011hr%2015min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26667" t="66328" r="63711" b="26673"/>
              <a:stretch>
                <a:fillRect/>
              </a:stretch>
            </p:blipFill>
            <p:spPr bwMode="auto">
              <a:xfrm>
                <a:off x="5029200" y="3733800"/>
                <a:ext cx="533400" cy="290380"/>
              </a:xfrm>
              <a:prstGeom prst="rect">
                <a:avLst/>
              </a:prstGeom>
              <a:noFill/>
              <a:ln w="19050">
                <a:noFill/>
              </a:ln>
            </p:spPr>
          </p:pic>
          <p:pic>
            <p:nvPicPr>
              <p:cNvPr id="38" name="Picture 4" descr="ftp://ftp.agri.gov.il/Technology/Postharvest/Elena/2014/PCR_34030_26_1_14/PCR%2034030%20neg2014-01-26%2011hr%2015min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55533" t="67817" r="26666" b="25167"/>
              <a:stretch>
                <a:fillRect/>
              </a:stretch>
            </p:blipFill>
            <p:spPr bwMode="auto">
              <a:xfrm>
                <a:off x="5562600" y="3733800"/>
                <a:ext cx="986808" cy="291067"/>
              </a:xfrm>
              <a:prstGeom prst="rect">
                <a:avLst/>
              </a:prstGeom>
              <a:noFill/>
              <a:ln w="19050">
                <a:noFill/>
              </a:ln>
            </p:spPr>
          </p:pic>
        </p:grpSp>
        <p:sp>
          <p:nvSpPr>
            <p:cNvPr id="30" name="Rectangle 29"/>
            <p:cNvSpPr/>
            <p:nvPr/>
          </p:nvSpPr>
          <p:spPr>
            <a:xfrm>
              <a:off x="6248400" y="3733800"/>
              <a:ext cx="1524000" cy="304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6248400" y="4114800"/>
              <a:ext cx="1524000" cy="304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18692305">
              <a:off x="6306264" y="3216647"/>
              <a:ext cx="957717" cy="3647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.e</a:t>
              </a:r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00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8692305">
              <a:off x="6807801" y="3261377"/>
              <a:ext cx="838202" cy="3647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/>
                </a:rPr>
                <a:t>1_1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8692305">
              <a:off x="7341202" y="3261377"/>
              <a:ext cx="838202" cy="3647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/>
                </a:rPr>
                <a:t>1_2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236467" y="3733806"/>
              <a:ext cx="1162603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LysM1</a:t>
              </a:r>
              <a:endPara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523070" y="4077175"/>
              <a:ext cx="877732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S</a:t>
              </a:r>
              <a:endPara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328354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121713" y="857772"/>
            <a:ext cx="3785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riginal gel of </a:t>
            </a:r>
            <a:r>
              <a:rPr lang="en-US" i="1" dirty="0" smtClean="0"/>
              <a:t>PeLysM2</a:t>
            </a:r>
            <a:r>
              <a:rPr lang="en-US" dirty="0" smtClean="0"/>
              <a:t> from </a:t>
            </a:r>
            <a:r>
              <a:rPr lang="en-US" dirty="0" smtClean="0"/>
              <a:t>S1C </a:t>
            </a:r>
            <a:r>
              <a:rPr lang="en-US" dirty="0" smtClean="0"/>
              <a:t>Fig.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r="41390"/>
          <a:stretch/>
        </p:blipFill>
        <p:spPr>
          <a:xfrm>
            <a:off x="6367290" y="1742328"/>
            <a:ext cx="3349587" cy="427672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r="40859"/>
          <a:stretch/>
        </p:blipFill>
        <p:spPr>
          <a:xfrm>
            <a:off x="652290" y="1610126"/>
            <a:ext cx="3379883" cy="427672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60572" y="1240794"/>
            <a:ext cx="1080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PeLysM2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8387294" y="1425460"/>
            <a:ext cx="1080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37S</a:t>
            </a:r>
            <a:endParaRPr lang="en-US" dirty="0"/>
          </a:p>
        </p:txBody>
      </p:sp>
      <p:grpSp>
        <p:nvGrpSpPr>
          <p:cNvPr id="7" name="Group 32"/>
          <p:cNvGrpSpPr>
            <a:grpSpLocks/>
          </p:cNvGrpSpPr>
          <p:nvPr/>
        </p:nvGrpSpPr>
        <p:grpSpPr>
          <a:xfrm>
            <a:off x="10744960" y="728181"/>
            <a:ext cx="905256" cy="205740"/>
            <a:chOff x="3607316" y="2743200"/>
            <a:chExt cx="1219199" cy="304800"/>
          </a:xfrm>
        </p:grpSpPr>
        <p:grpSp>
          <p:nvGrpSpPr>
            <p:cNvPr id="8" name="Group 29"/>
            <p:cNvGrpSpPr/>
            <p:nvPr/>
          </p:nvGrpSpPr>
          <p:grpSpPr>
            <a:xfrm>
              <a:off x="3618204" y="2743200"/>
              <a:ext cx="1197865" cy="304800"/>
              <a:chOff x="3618204" y="2743200"/>
              <a:chExt cx="1197865" cy="304800"/>
            </a:xfrm>
          </p:grpSpPr>
          <p:pic>
            <p:nvPicPr>
              <p:cNvPr id="10" name="Picture 2" descr="ftp://ftp.agri.gov.il/Technology/Postharvest/Elena/2014/PCR_19_3_14/PCR%202014-03-19%2013hr%2034min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46888" t="61990" r="46445" b="30884"/>
              <a:stretch>
                <a:fillRect/>
              </a:stretch>
            </p:blipFill>
            <p:spPr bwMode="auto">
              <a:xfrm>
                <a:off x="4451737" y="2743200"/>
                <a:ext cx="364332" cy="304800"/>
              </a:xfrm>
              <a:prstGeom prst="rect">
                <a:avLst/>
              </a:prstGeom>
              <a:noFill/>
            </p:spPr>
          </p:pic>
          <p:pic>
            <p:nvPicPr>
              <p:cNvPr id="11" name="Picture 2" descr="ftp://ftp.agri.gov.il/Technology/Postharvest/Elena/2014/PCR_19_3_14/PCR%202014-03-19%2013hr%2034min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37555" t="61950" r="57111" b="30923"/>
              <a:stretch>
                <a:fillRect/>
              </a:stretch>
            </p:blipFill>
            <p:spPr bwMode="auto">
              <a:xfrm>
                <a:off x="4201134" y="2743200"/>
                <a:ext cx="291465" cy="304800"/>
              </a:xfrm>
              <a:prstGeom prst="rect">
                <a:avLst/>
              </a:prstGeom>
              <a:noFill/>
            </p:spPr>
          </p:pic>
          <p:pic>
            <p:nvPicPr>
              <p:cNvPr id="12" name="Picture 2" descr="ftp://ftp.agri.gov.il/Technology/Postharvest/Elena/2014/PCR_19_3_14/PCR%202014-03-19%2013hr%2034min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16222" t="61950" r="73111" b="30923"/>
              <a:stretch>
                <a:fillRect/>
              </a:stretch>
            </p:blipFill>
            <p:spPr bwMode="auto">
              <a:xfrm>
                <a:off x="3618204" y="2743200"/>
                <a:ext cx="582930" cy="304800"/>
              </a:xfrm>
              <a:prstGeom prst="rect">
                <a:avLst/>
              </a:prstGeom>
              <a:noFill/>
            </p:spPr>
          </p:pic>
        </p:grpSp>
        <p:sp>
          <p:nvSpPr>
            <p:cNvPr id="9" name="Rectangle 8"/>
            <p:cNvSpPr/>
            <p:nvPr/>
          </p:nvSpPr>
          <p:spPr>
            <a:xfrm>
              <a:off x="3607316" y="2743200"/>
              <a:ext cx="1219199" cy="304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Group 33"/>
          <p:cNvGrpSpPr>
            <a:grpSpLocks/>
          </p:cNvGrpSpPr>
          <p:nvPr/>
        </p:nvGrpSpPr>
        <p:grpSpPr>
          <a:xfrm>
            <a:off x="10744960" y="981854"/>
            <a:ext cx="905256" cy="205740"/>
            <a:chOff x="3607316" y="3352800"/>
            <a:chExt cx="1219199" cy="304800"/>
          </a:xfrm>
        </p:grpSpPr>
        <p:grpSp>
          <p:nvGrpSpPr>
            <p:cNvPr id="14" name="Group 30"/>
            <p:cNvGrpSpPr/>
            <p:nvPr/>
          </p:nvGrpSpPr>
          <p:grpSpPr>
            <a:xfrm>
              <a:off x="3618204" y="3352800"/>
              <a:ext cx="1198568" cy="304800"/>
              <a:chOff x="3618204" y="3352800"/>
              <a:chExt cx="1198568" cy="304800"/>
            </a:xfrm>
          </p:grpSpPr>
          <p:pic>
            <p:nvPicPr>
              <p:cNvPr id="16" name="Picture 4" descr="ftp://ftp.agri.gov.il/Technology/Postharvest/Elena/2014/PCR%2037S_19_3_14/PCR%2037S%202014-03-19%2014hr%2022min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48000" t="57016" r="46444" b="35858"/>
              <a:stretch>
                <a:fillRect/>
              </a:stretch>
            </p:blipFill>
            <p:spPr bwMode="auto">
              <a:xfrm>
                <a:off x="4499272" y="3352800"/>
                <a:ext cx="317500" cy="304800"/>
              </a:xfrm>
              <a:prstGeom prst="rect">
                <a:avLst/>
              </a:prstGeom>
              <a:noFill/>
            </p:spPr>
          </p:pic>
          <p:pic>
            <p:nvPicPr>
              <p:cNvPr id="17" name="Picture 4" descr="ftp://ftp.agri.gov.il/Technology/Postharvest/Elena/2014/PCR%2037S_19_3_14/PCR%2037S%202014-03-19%2014hr%2022min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37333" t="57016" r="57333" b="35858"/>
              <a:stretch>
                <a:fillRect/>
              </a:stretch>
            </p:blipFill>
            <p:spPr bwMode="auto">
              <a:xfrm>
                <a:off x="4194471" y="3352800"/>
                <a:ext cx="304800" cy="304800"/>
              </a:xfrm>
              <a:prstGeom prst="rect">
                <a:avLst/>
              </a:prstGeom>
              <a:noFill/>
            </p:spPr>
          </p:pic>
          <p:pic>
            <p:nvPicPr>
              <p:cNvPr id="18" name="Picture 4" descr="ftp://ftp.agri.gov.il/Technology/Postharvest/Elena/2014/PCR%2037S_19_3_14/PCR%2037S%202014-03-19%2014hr%2022min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17333" t="57016" r="72000" b="35858"/>
              <a:stretch>
                <a:fillRect/>
              </a:stretch>
            </p:blipFill>
            <p:spPr bwMode="auto">
              <a:xfrm>
                <a:off x="3618204" y="3352800"/>
                <a:ext cx="609601" cy="304800"/>
              </a:xfrm>
              <a:prstGeom prst="rect">
                <a:avLst/>
              </a:prstGeom>
              <a:noFill/>
            </p:spPr>
          </p:pic>
        </p:grpSp>
        <p:sp>
          <p:nvSpPr>
            <p:cNvPr id="15" name="Rectangle 14"/>
            <p:cNvSpPr/>
            <p:nvPr/>
          </p:nvSpPr>
          <p:spPr>
            <a:xfrm>
              <a:off x="3607316" y="3352800"/>
              <a:ext cx="1219199" cy="304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10343107" y="950105"/>
            <a:ext cx="4691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S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0040575" y="705630"/>
            <a:ext cx="7997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LysM2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8692305">
            <a:off x="10620559" y="309620"/>
            <a:ext cx="789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8692305">
            <a:off x="10898781" y="406430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8692305">
            <a:off x="11119328" y="401304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1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8692305">
            <a:off x="11370078" y="396785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2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1740756" y="2451746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2106324" y="2496490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1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2688978" y="2560082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2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6200000">
            <a:off x="1329531" y="2451747"/>
            <a:ext cx="789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7467703" y="2604146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7786285" y="2657216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1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8673707" y="2715878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2_2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6200000">
            <a:off x="7056478" y="2604147"/>
            <a:ext cx="789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92386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29888"/>
          <a:stretch/>
        </p:blipFill>
        <p:spPr>
          <a:xfrm>
            <a:off x="6720289" y="1630324"/>
            <a:ext cx="4006926" cy="427672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20281" r="9744"/>
          <a:stretch/>
        </p:blipFill>
        <p:spPr>
          <a:xfrm>
            <a:off x="2137272" y="1630324"/>
            <a:ext cx="3999123" cy="42767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121713" y="857772"/>
            <a:ext cx="3785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riginal gel of </a:t>
            </a:r>
            <a:r>
              <a:rPr lang="en-US" i="1" dirty="0" smtClean="0"/>
              <a:t>PeLysM2</a:t>
            </a:r>
            <a:r>
              <a:rPr lang="en-US" dirty="0" smtClean="0"/>
              <a:t> from </a:t>
            </a:r>
            <a:r>
              <a:rPr lang="en-US" dirty="0" smtClean="0"/>
              <a:t>S1C </a:t>
            </a:r>
            <a:r>
              <a:rPr lang="en-US" dirty="0" smtClean="0"/>
              <a:t>Fig.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3359714" y="1339946"/>
            <a:ext cx="1080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PeLysM4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8398310" y="1339946"/>
            <a:ext cx="1080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37S</a:t>
            </a:r>
            <a:endParaRPr lang="en-US" dirty="0"/>
          </a:p>
        </p:txBody>
      </p:sp>
      <p:grpSp>
        <p:nvGrpSpPr>
          <p:cNvPr id="7" name="Group 6"/>
          <p:cNvGrpSpPr>
            <a:grpSpLocks/>
          </p:cNvGrpSpPr>
          <p:nvPr/>
        </p:nvGrpSpPr>
        <p:grpSpPr>
          <a:xfrm>
            <a:off x="10527160" y="971264"/>
            <a:ext cx="905256" cy="210312"/>
            <a:chOff x="2971800" y="2362200"/>
            <a:chExt cx="1752600" cy="392443"/>
          </a:xfrm>
        </p:grpSpPr>
        <p:pic>
          <p:nvPicPr>
            <p:cNvPr id="8" name="Picture 4" descr="ftp://ftp.agri.gov.il/Technology/Postharvest/Elena/2017/PCR_37S_14_2_17/PCR_37S%202017-02-14%2014hr%2041min.jpg"/>
            <p:cNvPicPr>
              <a:picLocks noChangeAspect="1" noChangeArrowheads="1"/>
            </p:cNvPicPr>
            <p:nvPr/>
          </p:nvPicPr>
          <p:blipFill>
            <a:blip r:embed="rId4" cstate="print"/>
            <a:srcRect l="42667" t="44543" r="28000" b="46548"/>
            <a:stretch>
              <a:fillRect/>
            </a:stretch>
          </p:blipFill>
          <p:spPr bwMode="auto">
            <a:xfrm>
              <a:off x="2971800" y="2362200"/>
              <a:ext cx="1752600" cy="392443"/>
            </a:xfrm>
            <a:prstGeom prst="rect">
              <a:avLst/>
            </a:prstGeom>
            <a:noFill/>
          </p:spPr>
        </p:pic>
        <p:sp>
          <p:nvSpPr>
            <p:cNvPr id="9" name="Rectangle 8"/>
            <p:cNvSpPr/>
            <p:nvPr/>
          </p:nvSpPr>
          <p:spPr>
            <a:xfrm>
              <a:off x="2971800" y="2362200"/>
              <a:ext cx="1752600" cy="381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" name="Group 9"/>
          <p:cNvGrpSpPr>
            <a:grpSpLocks/>
          </p:cNvGrpSpPr>
          <p:nvPr/>
        </p:nvGrpSpPr>
        <p:grpSpPr>
          <a:xfrm>
            <a:off x="10527160" y="705295"/>
            <a:ext cx="905256" cy="210312"/>
            <a:chOff x="2971800" y="2895600"/>
            <a:chExt cx="1752600" cy="381000"/>
          </a:xfrm>
        </p:grpSpPr>
        <p:pic>
          <p:nvPicPr>
            <p:cNvPr id="11" name="Picture 2" descr="ftp://ftp.agri.gov.il/Technology/Postharvest/Elena/2017/PCR_Lysm_15_2_17/PCR_Lysm4_%202017-02-15%2012hr%2033min.jpg"/>
            <p:cNvPicPr>
              <a:picLocks noChangeAspect="1" noChangeArrowheads="1"/>
            </p:cNvPicPr>
            <p:nvPr/>
          </p:nvPicPr>
          <p:blipFill>
            <a:blip r:embed="rId5" cstate="print"/>
            <a:srcRect l="32000" t="49889" r="37333" b="41202"/>
            <a:stretch>
              <a:fillRect/>
            </a:stretch>
          </p:blipFill>
          <p:spPr bwMode="auto">
            <a:xfrm>
              <a:off x="2989307" y="2895600"/>
              <a:ext cx="1735093" cy="377204"/>
            </a:xfrm>
            <a:prstGeom prst="rect">
              <a:avLst/>
            </a:prstGeom>
            <a:noFill/>
          </p:spPr>
        </p:pic>
        <p:sp>
          <p:nvSpPr>
            <p:cNvPr id="12" name="Rectangle 11"/>
            <p:cNvSpPr/>
            <p:nvPr/>
          </p:nvSpPr>
          <p:spPr>
            <a:xfrm>
              <a:off x="2971800" y="2895600"/>
              <a:ext cx="1752600" cy="381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0137016" y="950105"/>
            <a:ext cx="528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S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9821897" y="707354"/>
            <a:ext cx="7981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LysM4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8692305">
            <a:off x="11120935" y="368947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8692305">
            <a:off x="10667266" y="387644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1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8692305">
            <a:off x="10886237" y="386656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2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8692305">
            <a:off x="10428181" y="366212"/>
            <a:ext cx="6399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4009077" y="2405637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3121131" y="2563582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1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3498788" y="2563581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2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2670130" y="2650127"/>
            <a:ext cx="6399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8986874" y="2558037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8176047" y="2715982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1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8553704" y="2715981"/>
            <a:ext cx="565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4_2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7725046" y="2802527"/>
            <a:ext cx="6399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e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9489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216</Words>
  <Application>Microsoft Office PowerPoint</Application>
  <PresentationFormat>Widescreen</PresentationFormat>
  <Paragraphs>11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 Levin</dc:creator>
  <cp:lastModifiedBy>Elena Levin</cp:lastModifiedBy>
  <cp:revision>8</cp:revision>
  <dcterms:created xsi:type="dcterms:W3CDTF">2017-05-01T07:35:02Z</dcterms:created>
  <dcterms:modified xsi:type="dcterms:W3CDTF">2017-10-01T05:36:22Z</dcterms:modified>
</cp:coreProperties>
</file>